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1992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0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C197A50F-1198-50F6-58DB-A5222DE73E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62051305"/>
              </p:ext>
            </p:extLst>
          </p:nvPr>
        </p:nvGraphicFramePr>
        <p:xfrm>
          <a:off x="2600325" y="3368675"/>
          <a:ext cx="1657350" cy="2406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415293" imgH="3503146" progId="Prism8.Document">
                  <p:embed/>
                </p:oleObj>
              </mc:Choice>
              <mc:Fallback>
                <p:oleObj name="Prism 8" r:id="rId2" imgW="2415293" imgH="3503146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BDE5C6A8-49EC-EA37-9654-946F1D013E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00325" y="3368675"/>
                        <a:ext cx="1657350" cy="2406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070D8A83-5AAD-0D6B-559C-D7EB3CDC62AA}"/>
              </a:ext>
            </a:extLst>
          </p:cNvPr>
          <p:cNvSpPr txBox="1"/>
          <p:nvPr/>
        </p:nvSpPr>
        <p:spPr>
          <a:xfrm>
            <a:off x="309880" y="182880"/>
            <a:ext cx="6236971" cy="11671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on-specific neutralization activity (NT50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gains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VSV_SARS-CoV-2-SΔ19(G614)_Ren virus in plasma from PWH (open circles), in comparison with healthy donors (closed circles). Mann-Whitney U test was applied to calculate the statistical significance between unpaired group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7980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8</TotalTime>
  <Words>5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egan Bond</cp:lastModifiedBy>
  <cp:revision>72</cp:revision>
  <dcterms:created xsi:type="dcterms:W3CDTF">2022-01-10T11:03:11Z</dcterms:created>
  <dcterms:modified xsi:type="dcterms:W3CDTF">2024-05-01T12:43:39Z</dcterms:modified>
</cp:coreProperties>
</file>